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12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699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8628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3989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306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4261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737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9729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614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7918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660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473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6771C-4344-4DDB-B997-F66FD0B128A9}" type="datetimeFigureOut">
              <a:rPr kumimoji="1" lang="ja-JP" altLang="en-US" smtClean="0"/>
              <a:t>2020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1D883-31C2-4DC5-B991-EE186535B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6305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2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71" y="869672"/>
            <a:ext cx="8625709" cy="48635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200887" y="5733256"/>
            <a:ext cx="905163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, ingested EWH in the first period placebo in the second period; PE, ingested placebo in the first period and EWH in the second period</a:t>
            </a:r>
          </a:p>
        </p:txBody>
      </p:sp>
    </p:spTree>
    <p:extLst>
      <p:ext uri="{BB962C8B-B14F-4D97-AF65-F5344CB8AC3E}">
        <p14:creationId xmlns:p14="http://schemas.microsoft.com/office/powerpoint/2010/main" val="1857869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</TotalTime>
  <Words>28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USER</cp:lastModifiedBy>
  <cp:revision>6</cp:revision>
  <dcterms:created xsi:type="dcterms:W3CDTF">2019-10-10T02:46:49Z</dcterms:created>
  <dcterms:modified xsi:type="dcterms:W3CDTF">2020-06-19T00:01:21Z</dcterms:modified>
</cp:coreProperties>
</file>